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2.png" ContentType="image/png"/>
  <Override PartName="/ppt/media/image32.png" ContentType="image/png"/>
  <Override PartName="/ppt/media/image26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4.png" ContentType="image/png"/>
  <Override PartName="/ppt/media/image34.png" ContentType="image/png"/>
  <Override PartName="/ppt/media/image13.png" ContentType="image/png"/>
  <Override PartName="/ppt/media/image50.png" ContentType="image/png"/>
  <Override PartName="/ppt/media/image40.png" ContentType="image/png"/>
  <Override PartName="/ppt/media/image41.png" ContentType="image/png"/>
  <Override PartName="/ppt/media/image9.png" ContentType="image/png"/>
  <Override PartName="/ppt/media/image39.png" ContentType="image/png"/>
  <Override PartName="/ppt/media/image30.png" ContentType="image/png"/>
  <Override PartName="/ppt/media/image28.png" ContentType="image/png"/>
  <Override PartName="/ppt/media/image42.png" ContentType="image/png"/>
  <Override PartName="/ppt/media/image43.png" ContentType="image/png"/>
  <Override PartName="/ppt/media/image44.png" ContentType="image/png"/>
  <Override PartName="/ppt/media/image45.png" ContentType="image/png"/>
  <Override PartName="/ppt/media/image46.png" ContentType="image/png"/>
  <Override PartName="/ppt/media/image48.png" ContentType="image/png"/>
  <Override PartName="/ppt/media/image11.png" ContentType="image/png"/>
  <Override PartName="/ppt/media/image51.png" ContentType="image/png"/>
  <Override PartName="/ppt/media/image38.png" ContentType="image/png"/>
  <Override PartName="/ppt/media/image8.png" ContentType="image/png"/>
  <Override PartName="/ppt/media/image49.png" ContentType="image/png"/>
  <Override PartName="/ppt/media/image12.png" ContentType="image/png"/>
  <Override PartName="/ppt/media/image10.png" ContentType="image/png"/>
  <Override PartName="/ppt/media/image47.png" ContentType="image/png"/>
  <Override PartName="/ppt/media/image37.png" ContentType="image/png"/>
  <Override PartName="/ppt/media/image7.png" ContentType="image/png"/>
  <Override PartName="/ppt/media/image36.png" ContentType="image/png"/>
  <Override PartName="/ppt/media/image6.png" ContentType="image/png"/>
  <Override PartName="/ppt/media/image29.png" ContentType="image/png"/>
  <Override PartName="/ppt/media/image5.png" ContentType="image/png"/>
  <Override PartName="/ppt/media/image35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9144000" cy="6858000"/>
  <p:notesSz cx="6735763" cy="97996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F17270-F0CD-4EFF-8355-3B127DC0E7C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 algn="ctr">
              <a:buNone/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E48010-C933-4147-9244-5810AE3480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 algn="ctr">
              <a:buNone/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6D79A7-9BC5-4EC8-A8F8-7DE3CDCCABF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 algn="ctr">
              <a:buNone/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69BB17-32DF-4B2A-9744-A35FCA5B12D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 algn="ctr">
              <a:buNone/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26"/>
              </a:spcBef>
              <a:buNone/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898C5A-7A74-4ED9-B372-BE47F14494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 algn="ctr">
              <a:buNone/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DEB4F5-7CC7-4D77-BA76-B0B9B55EB8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 algn="ctr">
              <a:buNone/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9B0271-C1A5-412A-ABB6-98A8F73019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 algn="ctr">
              <a:buNone/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526D51-4BA9-46B7-8D75-1700665679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26"/>
              </a:spcBef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E99D90-5947-41EA-8FDA-32F68B1B51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 algn="ctr">
              <a:buNone/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5302E0-F3FD-423A-92E1-49AA49E304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 algn="ctr">
              <a:buNone/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58BE51-C982-4292-8130-DE2B438B54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 algn="ctr">
              <a:buNone/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4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43060E-3C29-4A65-B8DB-7E4B37621F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 algn="ctr">
              <a:buNone/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0" lang="en-US" sz="41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marL="320760" indent="-320760">
              <a:spcBef>
                <a:spcPts val="726"/>
              </a:spcBef>
              <a:buClr>
                <a:srgbClr val="000000"/>
              </a:buClr>
              <a:buFont typeface="Arial"/>
              <a:buChar char="•"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1" marL="695160" indent="-266400">
              <a:spcBef>
                <a:spcPts val="726"/>
              </a:spcBef>
              <a:buClr>
                <a:srgbClr val="000000"/>
              </a:buClr>
              <a:buFont typeface="Arial"/>
              <a:buChar char="–"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2" marL="1071720" indent="-214560">
              <a:spcBef>
                <a:spcPts val="726"/>
              </a:spcBef>
              <a:buClr>
                <a:srgbClr val="000000"/>
              </a:buClr>
              <a:buFont typeface="Arial"/>
              <a:buChar char="•"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3" marL="1500120" indent="-214200">
              <a:spcBef>
                <a:spcPts val="726"/>
              </a:spcBef>
              <a:buClr>
                <a:srgbClr val="000000"/>
              </a:buClr>
              <a:buFont typeface="Arial"/>
              <a:buChar char="–"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4" marL="1928880" indent="-214200">
              <a:spcBef>
                <a:spcPts val="726"/>
              </a:spcBef>
              <a:buClr>
                <a:srgbClr val="000000"/>
              </a:buClr>
              <a:buFont typeface="Arial"/>
              <a:buChar char="»"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5" marL="1928880" indent="-214200">
              <a:spcBef>
                <a:spcPts val="726"/>
              </a:spcBef>
              <a:buClr>
                <a:srgbClr val="000000"/>
              </a:buClr>
              <a:buFont typeface="Arial"/>
              <a:buChar char="»"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6" marL="1928880" indent="-214200">
              <a:spcBef>
                <a:spcPts val="726"/>
              </a:spcBef>
              <a:buClr>
                <a:srgbClr val="000000"/>
              </a:buClr>
              <a:buFont typeface="Arial"/>
              <a:buChar char="»"/>
              <a:tabLst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lstStyle>
            <a:lvl1pPr indent="0">
              <a:buNone/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>
              <a:buNone/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lstStyle>
            <a:lvl1pPr indent="0" algn="r">
              <a:buNone/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fld id="{891DA804-D8B6-4C0A-8562-C71865DFFF5D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6" Type="http://schemas.openxmlformats.org/officeDocument/2006/relationships/image" Target="../media/image9.png"/><Relationship Id="rId7" Type="http://schemas.openxmlformats.org/officeDocument/2006/relationships/image" Target="../media/image10.png"/><Relationship Id="rId8" Type="http://schemas.openxmlformats.org/officeDocument/2006/relationships/image" Target="../media/image11.png"/><Relationship Id="rId9" Type="http://schemas.openxmlformats.org/officeDocument/2006/relationships/image" Target="../media/image12.png"/><Relationship Id="rId10" Type="http://schemas.openxmlformats.org/officeDocument/2006/relationships/image" Target="../media/image13.png"/><Relationship Id="rId11" Type="http://schemas.openxmlformats.org/officeDocument/2006/relationships/image" Target="../media/image14.png"/><Relationship Id="rId12" Type="http://schemas.openxmlformats.org/officeDocument/2006/relationships/image" Target="../media/image15.png"/><Relationship Id="rId13" Type="http://schemas.openxmlformats.org/officeDocument/2006/relationships/image" Target="../media/image16.png"/><Relationship Id="rId14" Type="http://schemas.openxmlformats.org/officeDocument/2006/relationships/image" Target="../media/image17.png"/><Relationship Id="rId15" Type="http://schemas.openxmlformats.org/officeDocument/2006/relationships/image" Target="../media/image18.png"/><Relationship Id="rId16" Type="http://schemas.openxmlformats.org/officeDocument/2006/relationships/image" Target="../media/image19.png"/><Relationship Id="rId17" Type="http://schemas.openxmlformats.org/officeDocument/2006/relationships/image" Target="../media/image20.png"/><Relationship Id="rId18" Type="http://schemas.openxmlformats.org/officeDocument/2006/relationships/image" Target="../media/image21.png"/><Relationship Id="rId19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image" Target="../media/image23.png"/><Relationship Id="rId3" Type="http://schemas.openxmlformats.org/officeDocument/2006/relationships/image" Target="../media/image24.pn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image" Target="../media/image26.png"/><Relationship Id="rId3" Type="http://schemas.openxmlformats.org/officeDocument/2006/relationships/image" Target="../media/image27.png"/><Relationship Id="rId4" Type="http://schemas.openxmlformats.org/officeDocument/2006/relationships/image" Target="../media/image28.png"/><Relationship Id="rId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oleObject" Target="../embeddings/oleObject1.bin"/><Relationship Id="rId3" Type="http://schemas.openxmlformats.org/officeDocument/2006/relationships/image" Target="../media/image30.png"/><Relationship Id="rId4" Type="http://schemas.openxmlformats.org/officeDocument/2006/relationships/oleObject" Target="../embeddings/oleObject2.bin"/><Relationship Id="rId5" Type="http://schemas.openxmlformats.org/officeDocument/2006/relationships/image" Target="../media/image31.png"/><Relationship Id="rId6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image" Target="../media/image33.png"/><Relationship Id="rId3" Type="http://schemas.openxmlformats.org/officeDocument/2006/relationships/image" Target="../media/image34.png"/><Relationship Id="rId4" Type="http://schemas.openxmlformats.org/officeDocument/2006/relationships/image" Target="../media/image35.png"/><Relationship Id="rId5" Type="http://schemas.openxmlformats.org/officeDocument/2006/relationships/image" Target="../media/image36.png"/><Relationship Id="rId6" Type="http://schemas.openxmlformats.org/officeDocument/2006/relationships/image" Target="../media/image37.png"/><Relationship Id="rId7" Type="http://schemas.openxmlformats.org/officeDocument/2006/relationships/image" Target="../media/image38.png"/><Relationship Id="rId8" Type="http://schemas.openxmlformats.org/officeDocument/2006/relationships/image" Target="../media/image39.png"/><Relationship Id="rId9" Type="http://schemas.openxmlformats.org/officeDocument/2006/relationships/image" Target="../media/image40.png"/><Relationship Id="rId10" Type="http://schemas.openxmlformats.org/officeDocument/2006/relationships/image" Target="../media/image41.png"/><Relationship Id="rId11" Type="http://schemas.openxmlformats.org/officeDocument/2006/relationships/image" Target="../media/image42.png"/><Relationship Id="rId12" Type="http://schemas.openxmlformats.org/officeDocument/2006/relationships/image" Target="../media/image43.png"/><Relationship Id="rId1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44.png"/><Relationship Id="rId2" Type="http://schemas.openxmlformats.org/officeDocument/2006/relationships/image" Target="../media/image45.png"/><Relationship Id="rId3" Type="http://schemas.openxmlformats.org/officeDocument/2006/relationships/image" Target="../media/image46.png"/><Relationship Id="rId4" Type="http://schemas.openxmlformats.org/officeDocument/2006/relationships/image" Target="../media/image47.png"/><Relationship Id="rId5" Type="http://schemas.openxmlformats.org/officeDocument/2006/relationships/image" Target="../media/image48.png"/><Relationship Id="rId6" Type="http://schemas.openxmlformats.org/officeDocument/2006/relationships/image" Target="../media/image49.png"/><Relationship Id="rId7" Type="http://schemas.openxmlformats.org/officeDocument/2006/relationships/oleObject" Target="../embeddings/oleObject1.bin"/><Relationship Id="rId8" Type="http://schemas.openxmlformats.org/officeDocument/2006/relationships/image" Target="../media/image50.png"/><Relationship Id="rId9" Type="http://schemas.openxmlformats.org/officeDocument/2006/relationships/oleObject" Target="../embeddings/oleObject2.bin"/><Relationship Id="rId10" Type="http://schemas.openxmlformats.org/officeDocument/2006/relationships/image" Target="../media/image51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"/>
          <p:cNvSpPr/>
          <p:nvPr/>
        </p:nvSpPr>
        <p:spPr>
          <a:xfrm>
            <a:off x="82800" y="641196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组合 1"/>
          <p:cNvGrpSpPr/>
          <p:nvPr/>
        </p:nvGrpSpPr>
        <p:grpSpPr>
          <a:xfrm>
            <a:off x="219240" y="1676520"/>
            <a:ext cx="8619840" cy="2374920"/>
            <a:chOff x="219240" y="1676520"/>
            <a:chExt cx="8619840" cy="2374920"/>
          </a:xfrm>
        </p:grpSpPr>
        <p:pic>
          <p:nvPicPr>
            <p:cNvPr id="43" name="Picture 2" descr="E:\Research project\Autophagy project\miR-20 project\Manuscript\Autophagy\ER_mir20a.tif"/>
            <p:cNvPicPr/>
            <p:nvPr/>
          </p:nvPicPr>
          <p:blipFill>
            <a:blip r:embed="rId1"/>
            <a:srcRect l="0" t="0" r="7142" b="0"/>
            <a:stretch/>
          </p:blipFill>
          <p:spPr>
            <a:xfrm>
              <a:off x="219240" y="1688040"/>
              <a:ext cx="2741400" cy="2356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3" descr="E:\Research project\Autophagy project\miR-20 project\Manuscript\Autophagy\HER2_mir20a.tif"/>
            <p:cNvPicPr/>
            <p:nvPr/>
          </p:nvPicPr>
          <p:blipFill>
            <a:blip r:embed="rId2"/>
            <a:srcRect l="0" t="0" r="7142" b="0"/>
            <a:stretch/>
          </p:blipFill>
          <p:spPr>
            <a:xfrm>
              <a:off x="6097680" y="1695240"/>
              <a:ext cx="2741400" cy="2356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4" descr="E:\Research project\Autophagy project\miR-20 project\Manuscript\Autophagy\PR_mir20a.tif"/>
            <p:cNvPicPr/>
            <p:nvPr/>
          </p:nvPicPr>
          <p:blipFill>
            <a:blip r:embed="rId3"/>
            <a:srcRect l="0" t="0" r="7142" b="0"/>
            <a:stretch/>
          </p:blipFill>
          <p:spPr>
            <a:xfrm>
              <a:off x="3125880" y="1676520"/>
              <a:ext cx="2741400" cy="235620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组合 3"/>
          <p:cNvGrpSpPr/>
          <p:nvPr/>
        </p:nvGrpSpPr>
        <p:grpSpPr>
          <a:xfrm>
            <a:off x="246600" y="457200"/>
            <a:ext cx="4804920" cy="2730600"/>
            <a:chOff x="246600" y="457200"/>
            <a:chExt cx="4804920" cy="2730600"/>
          </a:xfrm>
        </p:grpSpPr>
        <p:pic>
          <p:nvPicPr>
            <p:cNvPr id="47" name="图片 4" descr=""/>
            <p:cNvPicPr/>
            <p:nvPr/>
          </p:nvPicPr>
          <p:blipFill>
            <a:blip r:embed="rId1"/>
            <a:stretch/>
          </p:blipFill>
          <p:spPr>
            <a:xfrm>
              <a:off x="1045800" y="766080"/>
              <a:ext cx="972000" cy="972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图片 5" descr=""/>
            <p:cNvPicPr/>
            <p:nvPr/>
          </p:nvPicPr>
          <p:blipFill>
            <a:blip r:embed="rId2"/>
            <a:stretch/>
          </p:blipFill>
          <p:spPr>
            <a:xfrm>
              <a:off x="1045800" y="1772640"/>
              <a:ext cx="972000" cy="972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图片 6" descr=""/>
            <p:cNvPicPr/>
            <p:nvPr/>
          </p:nvPicPr>
          <p:blipFill>
            <a:blip r:embed="rId3"/>
            <a:stretch/>
          </p:blipFill>
          <p:spPr>
            <a:xfrm>
              <a:off x="2053800" y="766080"/>
              <a:ext cx="972000" cy="972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图片 7" descr=""/>
            <p:cNvPicPr/>
            <p:nvPr/>
          </p:nvPicPr>
          <p:blipFill>
            <a:blip r:embed="rId4"/>
            <a:stretch/>
          </p:blipFill>
          <p:spPr>
            <a:xfrm>
              <a:off x="2053800" y="1772640"/>
              <a:ext cx="972000" cy="972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图片 8" descr=""/>
            <p:cNvPicPr/>
            <p:nvPr/>
          </p:nvPicPr>
          <p:blipFill>
            <a:blip r:embed="rId5"/>
            <a:stretch/>
          </p:blipFill>
          <p:spPr>
            <a:xfrm>
              <a:off x="3065040" y="1772640"/>
              <a:ext cx="972000" cy="972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图片 9" descr=""/>
            <p:cNvPicPr/>
            <p:nvPr/>
          </p:nvPicPr>
          <p:blipFill>
            <a:blip r:embed="rId6"/>
            <a:stretch/>
          </p:blipFill>
          <p:spPr>
            <a:xfrm>
              <a:off x="3065040" y="766080"/>
              <a:ext cx="972000" cy="972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图片 10" descr=""/>
            <p:cNvPicPr/>
            <p:nvPr/>
          </p:nvPicPr>
          <p:blipFill>
            <a:blip r:embed="rId7"/>
            <a:stretch/>
          </p:blipFill>
          <p:spPr>
            <a:xfrm>
              <a:off x="4079520" y="1772640"/>
              <a:ext cx="972000" cy="972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图片 11" descr=""/>
            <p:cNvPicPr/>
            <p:nvPr/>
          </p:nvPicPr>
          <p:blipFill>
            <a:blip r:embed="rId8"/>
            <a:stretch/>
          </p:blipFill>
          <p:spPr>
            <a:xfrm>
              <a:off x="4079520" y="766080"/>
              <a:ext cx="972000" cy="97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文本框 12"/>
            <p:cNvSpPr/>
            <p:nvPr/>
          </p:nvSpPr>
          <p:spPr>
            <a:xfrm>
              <a:off x="1375920" y="457200"/>
              <a:ext cx="3615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NC                 miR-20a                NC                miR-20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61"/>
            <p:cNvSpPr/>
            <p:nvPr/>
          </p:nvSpPr>
          <p:spPr>
            <a:xfrm>
              <a:off x="1742400" y="2926440"/>
              <a:ext cx="2664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</a:t>
              </a: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Ctrl                                             EBSS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左大括号 14"/>
            <p:cNvSpPr/>
            <p:nvPr/>
          </p:nvSpPr>
          <p:spPr>
            <a:xfrm rot="16200000">
              <a:off x="1978920" y="2071800"/>
              <a:ext cx="75960" cy="1548000"/>
            </a:xfrm>
            <a:custGeom>
              <a:avLst/>
              <a:gdLst>
                <a:gd name="textAreaLeft" fmla="*/ 48600 w 75960"/>
                <a:gd name="textAreaRight" fmla="*/ 76320 w 75960"/>
                <a:gd name="textAreaTop" fmla="*/ 1800 h 1548000"/>
                <a:gd name="textAreaBottom" fmla="*/ 1546200 h 1548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45"/>
                    <a:pt x="10800" y="89"/>
                  </a:cubicBezTo>
                  <a:lnTo>
                    <a:pt x="10800" y="10711"/>
                  </a:lnTo>
                  <a:cubicBezTo>
                    <a:pt x="10800" y="10756"/>
                    <a:pt x="5400" y="10800"/>
                    <a:pt x="0" y="10800"/>
                  </a:cubicBezTo>
                  <a:cubicBezTo>
                    <a:pt x="5400" y="10800"/>
                    <a:pt x="10800" y="10845"/>
                    <a:pt x="10800" y="10889"/>
                  </a:cubicBezTo>
                  <a:lnTo>
                    <a:pt x="10800" y="21511"/>
                  </a:lnTo>
                  <a:cubicBezTo>
                    <a:pt x="10800" y="21556"/>
                    <a:pt x="16200" y="21600"/>
                    <a:pt x="21600" y="21600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endParaRPr b="0" lang="en-US" sz="1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左大括号 15"/>
            <p:cNvSpPr/>
            <p:nvPr/>
          </p:nvSpPr>
          <p:spPr>
            <a:xfrm rot="16200000">
              <a:off x="4015080" y="2071800"/>
              <a:ext cx="75960" cy="1548000"/>
            </a:xfrm>
            <a:custGeom>
              <a:avLst/>
              <a:gdLst>
                <a:gd name="textAreaLeft" fmla="*/ 48600 w 75960"/>
                <a:gd name="textAreaRight" fmla="*/ 76320 w 75960"/>
                <a:gd name="textAreaTop" fmla="*/ 1800 h 1548000"/>
                <a:gd name="textAreaBottom" fmla="*/ 1546200 h 1548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45"/>
                    <a:pt x="10800" y="89"/>
                  </a:cubicBezTo>
                  <a:lnTo>
                    <a:pt x="10800" y="10711"/>
                  </a:lnTo>
                  <a:cubicBezTo>
                    <a:pt x="10800" y="10756"/>
                    <a:pt x="5400" y="10800"/>
                    <a:pt x="0" y="10800"/>
                  </a:cubicBezTo>
                  <a:cubicBezTo>
                    <a:pt x="5400" y="10800"/>
                    <a:pt x="10800" y="10845"/>
                    <a:pt x="10800" y="10889"/>
                  </a:cubicBezTo>
                  <a:lnTo>
                    <a:pt x="10800" y="21511"/>
                  </a:lnTo>
                  <a:cubicBezTo>
                    <a:pt x="10800" y="21556"/>
                    <a:pt x="16200" y="21600"/>
                    <a:pt x="21600" y="21600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endParaRPr b="0" lang="en-US" sz="1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文本框 16"/>
            <p:cNvSpPr/>
            <p:nvPr/>
          </p:nvSpPr>
          <p:spPr>
            <a:xfrm>
              <a:off x="246600" y="1149120"/>
              <a:ext cx="814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nti-LC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文本框 17"/>
            <p:cNvSpPr/>
            <p:nvPr/>
          </p:nvSpPr>
          <p:spPr>
            <a:xfrm>
              <a:off x="434880" y="2072880"/>
              <a:ext cx="545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API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1" name="TextBox 64"/>
          <p:cNvSpPr/>
          <p:nvPr/>
        </p:nvSpPr>
        <p:spPr>
          <a:xfrm>
            <a:off x="235080" y="624852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2" name="组合 66"/>
          <p:cNvGrpSpPr/>
          <p:nvPr/>
        </p:nvGrpSpPr>
        <p:grpSpPr>
          <a:xfrm>
            <a:off x="248400" y="3425760"/>
            <a:ext cx="4803120" cy="2724120"/>
            <a:chOff x="248400" y="3425760"/>
            <a:chExt cx="4803120" cy="2724120"/>
          </a:xfrm>
        </p:grpSpPr>
        <p:pic>
          <p:nvPicPr>
            <p:cNvPr id="63" name="图片 41" descr=""/>
            <p:cNvPicPr/>
            <p:nvPr/>
          </p:nvPicPr>
          <p:blipFill>
            <a:blip r:embed="rId9"/>
            <a:stretch/>
          </p:blipFill>
          <p:spPr>
            <a:xfrm>
              <a:off x="3063240" y="3734280"/>
              <a:ext cx="971640" cy="971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图片 43" descr=""/>
            <p:cNvPicPr/>
            <p:nvPr/>
          </p:nvPicPr>
          <p:blipFill>
            <a:blip r:embed="rId10"/>
            <a:stretch/>
          </p:blipFill>
          <p:spPr>
            <a:xfrm>
              <a:off x="3063960" y="4740480"/>
              <a:ext cx="971640" cy="971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图片 48" descr=""/>
            <p:cNvPicPr/>
            <p:nvPr/>
          </p:nvPicPr>
          <p:blipFill>
            <a:blip r:embed="rId11"/>
            <a:stretch/>
          </p:blipFill>
          <p:spPr>
            <a:xfrm>
              <a:off x="4076640" y="4740480"/>
              <a:ext cx="971640" cy="971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图片 50" descr=""/>
            <p:cNvPicPr/>
            <p:nvPr/>
          </p:nvPicPr>
          <p:blipFill>
            <a:blip r:embed="rId12"/>
            <a:stretch/>
          </p:blipFill>
          <p:spPr>
            <a:xfrm>
              <a:off x="4079880" y="3733920"/>
              <a:ext cx="971640" cy="971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图片 55" descr=""/>
            <p:cNvPicPr/>
            <p:nvPr/>
          </p:nvPicPr>
          <p:blipFill>
            <a:blip r:embed="rId13"/>
            <a:srcRect l="13560" t="0" r="5735" b="19827"/>
            <a:stretch/>
          </p:blipFill>
          <p:spPr>
            <a:xfrm>
              <a:off x="2054520" y="4740480"/>
              <a:ext cx="971640" cy="971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图片 56" descr=""/>
            <p:cNvPicPr/>
            <p:nvPr/>
          </p:nvPicPr>
          <p:blipFill>
            <a:blip r:embed="rId14"/>
            <a:srcRect l="13560" t="0" r="5735" b="19827"/>
            <a:stretch/>
          </p:blipFill>
          <p:spPr>
            <a:xfrm>
              <a:off x="2055240" y="3733920"/>
              <a:ext cx="971640" cy="971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图片 58" descr=""/>
            <p:cNvPicPr/>
            <p:nvPr/>
          </p:nvPicPr>
          <p:blipFill>
            <a:blip r:embed="rId15"/>
            <a:srcRect l="6428" t="2131" r="997" b="5294"/>
            <a:stretch/>
          </p:blipFill>
          <p:spPr>
            <a:xfrm>
              <a:off x="1050480" y="4742640"/>
              <a:ext cx="971640" cy="971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图片 59" descr=""/>
            <p:cNvPicPr/>
            <p:nvPr/>
          </p:nvPicPr>
          <p:blipFill>
            <a:blip r:embed="rId16"/>
            <a:srcRect l="6428" t="2131" r="997" b="5294"/>
            <a:stretch/>
          </p:blipFill>
          <p:spPr>
            <a:xfrm>
              <a:off x="1052640" y="3728880"/>
              <a:ext cx="971640" cy="971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1" name="文本框 60"/>
            <p:cNvSpPr/>
            <p:nvPr/>
          </p:nvSpPr>
          <p:spPr>
            <a:xfrm>
              <a:off x="1158840" y="3425760"/>
              <a:ext cx="3850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LNA-NC            LNA-20a            LNA-NC            LNA-20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文本框 61"/>
            <p:cNvSpPr/>
            <p:nvPr/>
          </p:nvSpPr>
          <p:spPr>
            <a:xfrm>
              <a:off x="248400" y="4114800"/>
              <a:ext cx="814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nti-LC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文本框 62"/>
            <p:cNvSpPr/>
            <p:nvPr/>
          </p:nvSpPr>
          <p:spPr>
            <a:xfrm>
              <a:off x="436680" y="5038560"/>
              <a:ext cx="545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API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61"/>
            <p:cNvSpPr/>
            <p:nvPr/>
          </p:nvSpPr>
          <p:spPr>
            <a:xfrm>
              <a:off x="1753920" y="5888520"/>
              <a:ext cx="2664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</a:t>
              </a: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Ctrl                                             EBSS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左大括号 64"/>
            <p:cNvSpPr/>
            <p:nvPr/>
          </p:nvSpPr>
          <p:spPr>
            <a:xfrm rot="16200000">
              <a:off x="1990800" y="5034240"/>
              <a:ext cx="75960" cy="1547640"/>
            </a:xfrm>
            <a:custGeom>
              <a:avLst/>
              <a:gdLst>
                <a:gd name="textAreaLeft" fmla="*/ 48600 w 75960"/>
                <a:gd name="textAreaRight" fmla="*/ 76320 w 75960"/>
                <a:gd name="textAreaTop" fmla="*/ 1800 h 1547640"/>
                <a:gd name="textAreaBottom" fmla="*/ 1545840 h 1547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45"/>
                    <a:pt x="10800" y="89"/>
                  </a:cubicBezTo>
                  <a:lnTo>
                    <a:pt x="10800" y="10711"/>
                  </a:lnTo>
                  <a:cubicBezTo>
                    <a:pt x="10800" y="10756"/>
                    <a:pt x="5400" y="10800"/>
                    <a:pt x="0" y="10800"/>
                  </a:cubicBezTo>
                  <a:cubicBezTo>
                    <a:pt x="5400" y="10800"/>
                    <a:pt x="10800" y="10845"/>
                    <a:pt x="10800" y="10889"/>
                  </a:cubicBezTo>
                  <a:lnTo>
                    <a:pt x="10800" y="21511"/>
                  </a:lnTo>
                  <a:cubicBezTo>
                    <a:pt x="10800" y="21556"/>
                    <a:pt x="16200" y="21600"/>
                    <a:pt x="21600" y="21600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endParaRPr b="0" lang="en-US" sz="1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左大括号 65"/>
            <p:cNvSpPr/>
            <p:nvPr/>
          </p:nvSpPr>
          <p:spPr>
            <a:xfrm rot="16200000">
              <a:off x="4026240" y="5034240"/>
              <a:ext cx="75960" cy="1547640"/>
            </a:xfrm>
            <a:custGeom>
              <a:avLst/>
              <a:gdLst>
                <a:gd name="textAreaLeft" fmla="*/ 48600 w 75960"/>
                <a:gd name="textAreaRight" fmla="*/ 76320 w 75960"/>
                <a:gd name="textAreaTop" fmla="*/ 1800 h 1547640"/>
                <a:gd name="textAreaBottom" fmla="*/ 1545840 h 1547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45"/>
                    <a:pt x="10800" y="89"/>
                  </a:cubicBezTo>
                  <a:lnTo>
                    <a:pt x="10800" y="10711"/>
                  </a:lnTo>
                  <a:cubicBezTo>
                    <a:pt x="10800" y="10756"/>
                    <a:pt x="5400" y="10800"/>
                    <a:pt x="0" y="10800"/>
                  </a:cubicBezTo>
                  <a:cubicBezTo>
                    <a:pt x="5400" y="10800"/>
                    <a:pt x="10800" y="10845"/>
                    <a:pt x="10800" y="10889"/>
                  </a:cubicBezTo>
                  <a:lnTo>
                    <a:pt x="10800" y="21511"/>
                  </a:lnTo>
                  <a:cubicBezTo>
                    <a:pt x="10800" y="21556"/>
                    <a:pt x="16200" y="21600"/>
                    <a:pt x="21600" y="21600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endParaRPr b="0" lang="en-US" sz="17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7" name="TextBox 8"/>
          <p:cNvSpPr/>
          <p:nvPr/>
        </p:nvSpPr>
        <p:spPr>
          <a:xfrm>
            <a:off x="221760" y="257040"/>
            <a:ext cx="304200" cy="325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8" name="组合 2"/>
          <p:cNvGrpSpPr/>
          <p:nvPr/>
        </p:nvGrpSpPr>
        <p:grpSpPr>
          <a:xfrm>
            <a:off x="5472000" y="719280"/>
            <a:ext cx="3043440" cy="2444760"/>
            <a:chOff x="5472000" y="719280"/>
            <a:chExt cx="3043440" cy="2444760"/>
          </a:xfrm>
        </p:grpSpPr>
        <p:grpSp>
          <p:nvGrpSpPr>
            <p:cNvPr id="79" name="组合 20"/>
            <p:cNvGrpSpPr/>
            <p:nvPr/>
          </p:nvGrpSpPr>
          <p:grpSpPr>
            <a:xfrm>
              <a:off x="5472000" y="719280"/>
              <a:ext cx="3043440" cy="2444760"/>
              <a:chOff x="5472000" y="719280"/>
              <a:chExt cx="3043440" cy="2444760"/>
            </a:xfrm>
          </p:grpSpPr>
          <p:pic>
            <p:nvPicPr>
              <p:cNvPr id="80" name="图表 18" descr=""/>
              <p:cNvPicPr/>
              <p:nvPr/>
            </p:nvPicPr>
            <p:blipFill>
              <a:blip r:embed="rId17"/>
              <a:stretch/>
            </p:blipFill>
            <p:spPr>
              <a:xfrm>
                <a:off x="5796720" y="719280"/>
                <a:ext cx="2718720" cy="24447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1" name="TextBox 18"/>
              <p:cNvSpPr/>
              <p:nvPr/>
            </p:nvSpPr>
            <p:spPr>
              <a:xfrm rot="16200000">
                <a:off x="4511880" y="1684800"/>
                <a:ext cx="21816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57160"/>
                    <a:tab algn="l" pos="1714680"/>
                    <a:tab algn="l" pos="2571840"/>
                    <a:tab algn="l" pos="3429000"/>
                    <a:tab algn="l" pos="4286160"/>
                    <a:tab algn="l" pos="5143680"/>
                    <a:tab algn="l" pos="6000840"/>
                    <a:tab algn="l" pos="6858000"/>
                    <a:tab algn="l" pos="7715160"/>
                    <a:tab algn="l" pos="8572680"/>
                    <a:tab algn="l" pos="9429840"/>
                    <a:tab algn="l" pos="10287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umber of LC3 dots per cell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82" name="文本框 1"/>
            <p:cNvSpPr/>
            <p:nvPr/>
          </p:nvSpPr>
          <p:spPr>
            <a:xfrm>
              <a:off x="7823160" y="1190520"/>
              <a:ext cx="320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3" name="组合 23"/>
          <p:cNvGrpSpPr/>
          <p:nvPr/>
        </p:nvGrpSpPr>
        <p:grpSpPr>
          <a:xfrm>
            <a:off x="5486400" y="3514680"/>
            <a:ext cx="3033720" cy="2428920"/>
            <a:chOff x="5486400" y="3514680"/>
            <a:chExt cx="3033720" cy="2428920"/>
          </a:xfrm>
        </p:grpSpPr>
        <p:grpSp>
          <p:nvGrpSpPr>
            <p:cNvPr id="84" name="组合 69"/>
            <p:cNvGrpSpPr/>
            <p:nvPr/>
          </p:nvGrpSpPr>
          <p:grpSpPr>
            <a:xfrm>
              <a:off x="5486400" y="3514680"/>
              <a:ext cx="3033720" cy="2428920"/>
              <a:chOff x="5486400" y="3514680"/>
              <a:chExt cx="3033720" cy="2428920"/>
            </a:xfrm>
          </p:grpSpPr>
          <p:pic>
            <p:nvPicPr>
              <p:cNvPr id="85" name="图表 67" descr=""/>
              <p:cNvPicPr/>
              <p:nvPr/>
            </p:nvPicPr>
            <p:blipFill>
              <a:blip r:embed="rId18"/>
              <a:stretch/>
            </p:blipFill>
            <p:spPr>
              <a:xfrm>
                <a:off x="5814720" y="3514680"/>
                <a:ext cx="2705400" cy="2428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6" name="TextBox 18"/>
              <p:cNvSpPr/>
              <p:nvPr/>
            </p:nvSpPr>
            <p:spPr>
              <a:xfrm rot="16200000">
                <a:off x="4525200" y="4506120"/>
                <a:ext cx="21837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57160"/>
                    <a:tab algn="l" pos="1714680"/>
                    <a:tab algn="l" pos="2571840"/>
                    <a:tab algn="l" pos="3429000"/>
                    <a:tab algn="l" pos="4286160"/>
                    <a:tab algn="l" pos="5143680"/>
                    <a:tab algn="l" pos="6000840"/>
                    <a:tab algn="l" pos="6858000"/>
                    <a:tab algn="l" pos="7715160"/>
                    <a:tab algn="l" pos="8572680"/>
                    <a:tab algn="l" pos="9429840"/>
                    <a:tab algn="l" pos="10287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umber of LC3 dots per cell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87" name="文本框 22"/>
            <p:cNvSpPr/>
            <p:nvPr/>
          </p:nvSpPr>
          <p:spPr>
            <a:xfrm>
              <a:off x="7870320" y="361908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TextBox 64"/>
          <p:cNvSpPr/>
          <p:nvPr/>
        </p:nvSpPr>
        <p:spPr>
          <a:xfrm>
            <a:off x="235080" y="624852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igure S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9" name="组合 4"/>
          <p:cNvGrpSpPr/>
          <p:nvPr/>
        </p:nvGrpSpPr>
        <p:grpSpPr>
          <a:xfrm>
            <a:off x="422280" y="1371600"/>
            <a:ext cx="8717400" cy="3463920"/>
            <a:chOff x="422280" y="1371600"/>
            <a:chExt cx="8717400" cy="3463920"/>
          </a:xfrm>
        </p:grpSpPr>
        <p:grpSp>
          <p:nvGrpSpPr>
            <p:cNvPr id="90" name="组合 15"/>
            <p:cNvGrpSpPr/>
            <p:nvPr/>
          </p:nvGrpSpPr>
          <p:grpSpPr>
            <a:xfrm>
              <a:off x="422280" y="1904760"/>
              <a:ext cx="2649960" cy="2895840"/>
              <a:chOff x="422280" y="1904760"/>
              <a:chExt cx="2649960" cy="2895840"/>
            </a:xfrm>
          </p:grpSpPr>
          <p:pic>
            <p:nvPicPr>
              <p:cNvPr id="91" name="图表 11" descr=""/>
              <p:cNvPicPr/>
              <p:nvPr/>
            </p:nvPicPr>
            <p:blipFill>
              <a:blip r:embed="rId1"/>
              <a:stretch/>
            </p:blipFill>
            <p:spPr>
              <a:xfrm>
                <a:off x="778680" y="1904760"/>
                <a:ext cx="2293560" cy="2895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2" name="文本框 2"/>
              <p:cNvSpPr/>
              <p:nvPr/>
            </p:nvSpPr>
            <p:spPr>
              <a:xfrm rot="16200000">
                <a:off x="-534240" y="3054600"/>
                <a:ext cx="237240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857160"/>
                    <a:tab algn="l" pos="1714680"/>
                    <a:tab algn="l" pos="2571840"/>
                    <a:tab algn="l" pos="3429000"/>
                    <a:tab algn="l" pos="4286160"/>
                    <a:tab algn="l" pos="5143680"/>
                    <a:tab algn="l" pos="6000840"/>
                    <a:tab algn="l" pos="6858000"/>
                    <a:tab algn="l" pos="7715160"/>
                    <a:tab algn="l" pos="8572680"/>
                    <a:tab algn="l" pos="9429840"/>
                    <a:tab algn="l" pos="10287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elative levels of endogenous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857160"/>
                    <a:tab algn="l" pos="1714680"/>
                    <a:tab algn="l" pos="2571840"/>
                    <a:tab algn="l" pos="3429000"/>
                    <a:tab algn="l" pos="4286160"/>
                    <a:tab algn="l" pos="5143680"/>
                    <a:tab algn="l" pos="6000840"/>
                    <a:tab algn="l" pos="6858000"/>
                    <a:tab algn="l" pos="7715160"/>
                    <a:tab algn="l" pos="8572680"/>
                    <a:tab algn="l" pos="9429840"/>
                    <a:tab algn="l" pos="10287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iR-20a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93" name="组合 14"/>
            <p:cNvGrpSpPr/>
            <p:nvPr/>
          </p:nvGrpSpPr>
          <p:grpSpPr>
            <a:xfrm>
              <a:off x="3217320" y="1931040"/>
              <a:ext cx="2539080" cy="2904480"/>
              <a:chOff x="3217320" y="1931040"/>
              <a:chExt cx="2539080" cy="2904480"/>
            </a:xfrm>
          </p:grpSpPr>
          <p:pic>
            <p:nvPicPr>
              <p:cNvPr id="94" name="图表 12" descr=""/>
              <p:cNvPicPr/>
              <p:nvPr/>
            </p:nvPicPr>
            <p:blipFill>
              <a:blip r:embed="rId2"/>
              <a:stretch/>
            </p:blipFill>
            <p:spPr>
              <a:xfrm>
                <a:off x="3461400" y="1931040"/>
                <a:ext cx="2295000" cy="29044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5" name="文本框 13"/>
              <p:cNvSpPr/>
              <p:nvPr/>
            </p:nvSpPr>
            <p:spPr>
              <a:xfrm rot="16200000">
                <a:off x="2325600" y="3157560"/>
                <a:ext cx="2059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857160"/>
                    <a:tab algn="l" pos="1714680"/>
                    <a:tab algn="l" pos="2571840"/>
                    <a:tab algn="l" pos="3429000"/>
                    <a:tab algn="l" pos="4286160"/>
                    <a:tab algn="l" pos="5143680"/>
                    <a:tab algn="l" pos="6000840"/>
                    <a:tab algn="l" pos="6858000"/>
                    <a:tab algn="l" pos="7715160"/>
                    <a:tab algn="l" pos="8572680"/>
                    <a:tab algn="l" pos="9429840"/>
                    <a:tab algn="l" pos="10287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elative levels of miR-20a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96" name="TextBox 8"/>
            <p:cNvSpPr/>
            <p:nvPr/>
          </p:nvSpPr>
          <p:spPr>
            <a:xfrm>
              <a:off x="603000" y="1371600"/>
              <a:ext cx="8536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a                                           b                                              c                                                     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97" name="组合 3"/>
            <p:cNvGrpSpPr/>
            <p:nvPr/>
          </p:nvGrpSpPr>
          <p:grpSpPr>
            <a:xfrm>
              <a:off x="5860440" y="1896120"/>
              <a:ext cx="2639160" cy="2904480"/>
              <a:chOff x="5860440" y="1896120"/>
              <a:chExt cx="2639160" cy="2904480"/>
            </a:xfrm>
          </p:grpSpPr>
          <p:pic>
            <p:nvPicPr>
              <p:cNvPr id="98" name="图表 16" descr=""/>
              <p:cNvPicPr/>
              <p:nvPr/>
            </p:nvPicPr>
            <p:blipFill>
              <a:blip r:embed="rId3"/>
              <a:stretch/>
            </p:blipFill>
            <p:spPr>
              <a:xfrm>
                <a:off x="6131520" y="1896120"/>
                <a:ext cx="2368080" cy="29044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9" name="文本框 17"/>
              <p:cNvSpPr/>
              <p:nvPr/>
            </p:nvSpPr>
            <p:spPr>
              <a:xfrm rot="16200000">
                <a:off x="4968720" y="3171240"/>
                <a:ext cx="2059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857160"/>
                    <a:tab algn="l" pos="1714680"/>
                    <a:tab algn="l" pos="2571840"/>
                    <a:tab algn="l" pos="3429000"/>
                    <a:tab algn="l" pos="4286160"/>
                    <a:tab algn="l" pos="5143680"/>
                    <a:tab algn="l" pos="6000840"/>
                    <a:tab algn="l" pos="6858000"/>
                    <a:tab algn="l" pos="7715160"/>
                    <a:tab algn="l" pos="8572680"/>
                    <a:tab algn="l" pos="9429840"/>
                    <a:tab algn="l" pos="10287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elative levels of miR-20a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0" name="组合 9"/>
          <p:cNvGrpSpPr/>
          <p:nvPr/>
        </p:nvGrpSpPr>
        <p:grpSpPr>
          <a:xfrm>
            <a:off x="380880" y="246240"/>
            <a:ext cx="3770280" cy="2877840"/>
            <a:chOff x="380880" y="246240"/>
            <a:chExt cx="3770280" cy="2877840"/>
          </a:xfrm>
        </p:grpSpPr>
        <p:pic>
          <p:nvPicPr>
            <p:cNvPr id="101" name="图表 3" descr=""/>
            <p:cNvPicPr/>
            <p:nvPr/>
          </p:nvPicPr>
          <p:blipFill>
            <a:blip r:embed="rId1"/>
            <a:stretch/>
          </p:blipFill>
          <p:spPr>
            <a:xfrm>
              <a:off x="663840" y="590760"/>
              <a:ext cx="3487320" cy="2533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2" name="文本框 5"/>
            <p:cNvSpPr/>
            <p:nvPr/>
          </p:nvSpPr>
          <p:spPr>
            <a:xfrm>
              <a:off x="2062440" y="246240"/>
              <a:ext cx="595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CF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文本框 7"/>
            <p:cNvSpPr/>
            <p:nvPr/>
          </p:nvSpPr>
          <p:spPr>
            <a:xfrm rot="16200000">
              <a:off x="-496800" y="1546920"/>
              <a:ext cx="2032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rmalized protein level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4" name="组合 10"/>
          <p:cNvGrpSpPr/>
          <p:nvPr/>
        </p:nvGrpSpPr>
        <p:grpSpPr>
          <a:xfrm>
            <a:off x="428760" y="3362400"/>
            <a:ext cx="3738600" cy="2809800"/>
            <a:chOff x="428760" y="3362400"/>
            <a:chExt cx="3738600" cy="2809800"/>
          </a:xfrm>
        </p:grpSpPr>
        <p:pic>
          <p:nvPicPr>
            <p:cNvPr id="105" name="图表 4" descr=""/>
            <p:cNvPicPr/>
            <p:nvPr/>
          </p:nvPicPr>
          <p:blipFill>
            <a:blip r:embed="rId2"/>
            <a:stretch/>
          </p:blipFill>
          <p:spPr>
            <a:xfrm>
              <a:off x="700560" y="3633480"/>
              <a:ext cx="3466800" cy="2538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6" name="文本框 6"/>
            <p:cNvSpPr/>
            <p:nvPr/>
          </p:nvSpPr>
          <p:spPr>
            <a:xfrm>
              <a:off x="2104560" y="3362400"/>
              <a:ext cx="595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CF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文本框 8"/>
            <p:cNvSpPr/>
            <p:nvPr/>
          </p:nvSpPr>
          <p:spPr>
            <a:xfrm rot="16200000">
              <a:off x="-448920" y="4771080"/>
              <a:ext cx="2032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rmalized protein level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8" name="组合 14"/>
          <p:cNvGrpSpPr/>
          <p:nvPr/>
        </p:nvGrpSpPr>
        <p:grpSpPr>
          <a:xfrm>
            <a:off x="4724280" y="3352680"/>
            <a:ext cx="3733920" cy="2819520"/>
            <a:chOff x="4724280" y="3352680"/>
            <a:chExt cx="3733920" cy="2819520"/>
          </a:xfrm>
        </p:grpSpPr>
        <p:pic>
          <p:nvPicPr>
            <p:cNvPr id="109" name="图表 11" descr=""/>
            <p:cNvPicPr/>
            <p:nvPr/>
          </p:nvPicPr>
          <p:blipFill>
            <a:blip r:embed="rId3"/>
            <a:stretch/>
          </p:blipFill>
          <p:spPr>
            <a:xfrm>
              <a:off x="4992840" y="3632760"/>
              <a:ext cx="3465360" cy="2539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0" name="文本框 12"/>
            <p:cNvSpPr/>
            <p:nvPr/>
          </p:nvSpPr>
          <p:spPr>
            <a:xfrm>
              <a:off x="6236280" y="3352680"/>
              <a:ext cx="1119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DA-MB-23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文本框 13"/>
            <p:cNvSpPr/>
            <p:nvPr/>
          </p:nvSpPr>
          <p:spPr>
            <a:xfrm rot="16200000">
              <a:off x="3846240" y="4770720"/>
              <a:ext cx="2032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rmalized protein level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12" name="TextBox 64"/>
          <p:cNvSpPr/>
          <p:nvPr/>
        </p:nvSpPr>
        <p:spPr>
          <a:xfrm>
            <a:off x="235080" y="640080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igure S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13" name="组合 2"/>
          <p:cNvGrpSpPr/>
          <p:nvPr/>
        </p:nvGrpSpPr>
        <p:grpSpPr>
          <a:xfrm>
            <a:off x="4724280" y="246240"/>
            <a:ext cx="3672000" cy="2854080"/>
            <a:chOff x="4724280" y="246240"/>
            <a:chExt cx="3672000" cy="2854080"/>
          </a:xfrm>
        </p:grpSpPr>
        <p:grpSp>
          <p:nvGrpSpPr>
            <p:cNvPr id="114" name="组合 1"/>
            <p:cNvGrpSpPr/>
            <p:nvPr/>
          </p:nvGrpSpPr>
          <p:grpSpPr>
            <a:xfrm>
              <a:off x="4928760" y="246240"/>
              <a:ext cx="3467520" cy="2854080"/>
              <a:chOff x="4928760" y="246240"/>
              <a:chExt cx="3467520" cy="2854080"/>
            </a:xfrm>
          </p:grpSpPr>
          <p:pic>
            <p:nvPicPr>
              <p:cNvPr id="115" name="图表 17" descr=""/>
              <p:cNvPicPr/>
              <p:nvPr/>
            </p:nvPicPr>
            <p:blipFill>
              <a:blip r:embed="rId4"/>
              <a:stretch/>
            </p:blipFill>
            <p:spPr>
              <a:xfrm>
                <a:off x="4928760" y="559800"/>
                <a:ext cx="3467520" cy="2540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6" name="文本框 18"/>
              <p:cNvSpPr/>
              <p:nvPr/>
            </p:nvSpPr>
            <p:spPr>
              <a:xfrm>
                <a:off x="6297480" y="246240"/>
                <a:ext cx="1119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857160"/>
                    <a:tab algn="l" pos="1714680"/>
                    <a:tab algn="l" pos="2571840"/>
                    <a:tab algn="l" pos="3429000"/>
                    <a:tab algn="l" pos="4286160"/>
                    <a:tab algn="l" pos="5143680"/>
                    <a:tab algn="l" pos="6000840"/>
                    <a:tab algn="l" pos="6858000"/>
                    <a:tab algn="l" pos="7715160"/>
                    <a:tab algn="l" pos="8572680"/>
                    <a:tab algn="l" pos="9429840"/>
                    <a:tab algn="l" pos="10287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DA-MB-231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17" name="文本框 19"/>
            <p:cNvSpPr/>
            <p:nvPr/>
          </p:nvSpPr>
          <p:spPr>
            <a:xfrm rot="16200000">
              <a:off x="3846240" y="1648080"/>
              <a:ext cx="2032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rmalized protein level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8" name="组合 14"/>
          <p:cNvGrpSpPr/>
          <p:nvPr/>
        </p:nvGrpSpPr>
        <p:grpSpPr>
          <a:xfrm>
            <a:off x="2682360" y="2824920"/>
            <a:ext cx="3378600" cy="2680560"/>
            <a:chOff x="2682360" y="2824920"/>
            <a:chExt cx="3378600" cy="2680560"/>
          </a:xfrm>
        </p:grpSpPr>
        <p:pic>
          <p:nvPicPr>
            <p:cNvPr id="119" name="图表 15" descr=""/>
            <p:cNvPicPr/>
            <p:nvPr/>
          </p:nvPicPr>
          <p:blipFill>
            <a:blip r:embed="rId1"/>
            <a:stretch/>
          </p:blipFill>
          <p:spPr>
            <a:xfrm>
              <a:off x="3004560" y="2919960"/>
              <a:ext cx="3056400" cy="2127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0" name="TextBox 3"/>
            <p:cNvSpPr/>
            <p:nvPr/>
          </p:nvSpPr>
          <p:spPr>
            <a:xfrm rot="16200000">
              <a:off x="1812600" y="3774960"/>
              <a:ext cx="2161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Relative ratios of LCII/GAPDH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文本框 17"/>
            <p:cNvSpPr/>
            <p:nvPr/>
          </p:nvSpPr>
          <p:spPr>
            <a:xfrm>
              <a:off x="2742840" y="5020200"/>
              <a:ext cx="33080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CQ       -        -       +       +       -        -       +       +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文本框 18"/>
            <p:cNvSpPr/>
            <p:nvPr/>
          </p:nvSpPr>
          <p:spPr>
            <a:xfrm>
              <a:off x="2682360" y="5244120"/>
              <a:ext cx="3376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EBSS       -        -        -       -       +        +      +       +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3" name="组合 21"/>
          <p:cNvGrpSpPr/>
          <p:nvPr/>
        </p:nvGrpSpPr>
        <p:grpSpPr>
          <a:xfrm>
            <a:off x="2441880" y="990720"/>
            <a:ext cx="4350240" cy="1582560"/>
            <a:chOff x="2441880" y="990720"/>
            <a:chExt cx="4350240" cy="1582560"/>
          </a:xfrm>
        </p:grpSpPr>
        <p:graphicFrame>
          <p:nvGraphicFramePr>
            <p:cNvPr id="124" name="Object 107"/>
            <p:cNvGraphicFramePr/>
            <p:nvPr/>
          </p:nvGraphicFramePr>
          <p:xfrm>
            <a:off x="2860920" y="2285280"/>
            <a:ext cx="3240360" cy="288000"/>
          </p:xfrm>
          <a:graphic>
            <a:graphicData uri="http://schemas.openxmlformats.org/presentationml/2006/ole">
              <p:oleObj r:id="rId2" spid="">
                <p:embed/>
                <p:pic>
                  <p:nvPicPr>
                    <p:cNvPr id="125" name="Object 107" descr=""/>
                    <p:cNvPicPr/>
                    <p:nvPr/>
                  </p:nvPicPr>
                  <p:blipFill>
                    <a:blip r:embed="rId3"/>
                    <a:stretch/>
                  </p:blipFill>
                  <p:spPr>
                    <a:xfrm>
                      <a:off x="2860920" y="2285280"/>
                      <a:ext cx="3240360" cy="288000"/>
                    </a:xfrm>
                    <a:prstGeom prst="rect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sp>
          <p:nvSpPr>
            <p:cNvPr id="126" name="TextBox 6"/>
            <p:cNvSpPr/>
            <p:nvPr/>
          </p:nvSpPr>
          <p:spPr>
            <a:xfrm>
              <a:off x="2962440" y="1558080"/>
              <a:ext cx="3030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NC    20A      NC     20A     NC     20A    NC     20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TextBox 5"/>
            <p:cNvSpPr/>
            <p:nvPr/>
          </p:nvSpPr>
          <p:spPr>
            <a:xfrm>
              <a:off x="2441880" y="133092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HCQ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TextBox 8"/>
            <p:cNvSpPr/>
            <p:nvPr/>
          </p:nvSpPr>
          <p:spPr>
            <a:xfrm>
              <a:off x="2898720" y="1338840"/>
              <a:ext cx="312480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 </a:t>
              </a: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-         -         +        +         -         -         +        +        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直接连接符 9"/>
            <p:cNvSpPr/>
            <p:nvPr/>
          </p:nvSpPr>
          <p:spPr>
            <a:xfrm>
              <a:off x="2937240" y="1295640"/>
              <a:ext cx="14040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TextBox 18"/>
            <p:cNvSpPr/>
            <p:nvPr/>
          </p:nvSpPr>
          <p:spPr>
            <a:xfrm>
              <a:off x="3242520" y="990720"/>
              <a:ext cx="23083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</a:t>
              </a: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Ctrl                                   EBSS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直接连接符 11"/>
            <p:cNvSpPr/>
            <p:nvPr/>
          </p:nvSpPr>
          <p:spPr>
            <a:xfrm>
              <a:off x="4533480" y="1295640"/>
              <a:ext cx="14040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文本框 12"/>
            <p:cNvSpPr/>
            <p:nvPr/>
          </p:nvSpPr>
          <p:spPr>
            <a:xfrm>
              <a:off x="6103800" y="1818720"/>
              <a:ext cx="57096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-I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-II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文本框 13"/>
            <p:cNvSpPr/>
            <p:nvPr/>
          </p:nvSpPr>
          <p:spPr>
            <a:xfrm>
              <a:off x="6107040" y="2294640"/>
              <a:ext cx="685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PDH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aphicFrame>
          <p:nvGraphicFramePr>
            <p:cNvPr id="134" name="Object 108"/>
            <p:cNvGraphicFramePr/>
            <p:nvPr/>
          </p:nvGraphicFramePr>
          <p:xfrm>
            <a:off x="2855520" y="1845720"/>
            <a:ext cx="3240360" cy="360000"/>
          </p:xfrm>
          <a:graphic>
            <a:graphicData uri="http://schemas.openxmlformats.org/presentationml/2006/ole">
              <p:oleObj r:id="rId4" spid="">
                <p:embed/>
                <p:pic>
                  <p:nvPicPr>
                    <p:cNvPr id="135" name="Object 108" descr=""/>
                    <p:cNvPicPr/>
                    <p:nvPr/>
                  </p:nvPicPr>
                  <p:blipFill>
                    <a:blip r:embed="rId5"/>
                    <a:stretch/>
                  </p:blipFill>
                  <p:spPr>
                    <a:xfrm>
                      <a:off x="2855520" y="1845720"/>
                      <a:ext cx="3240360" cy="360000"/>
                    </a:xfrm>
                    <a:prstGeom prst="rect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</p:grpSp>
      <p:sp>
        <p:nvSpPr>
          <p:cNvPr id="136" name="TextBox 64"/>
          <p:cNvSpPr/>
          <p:nvPr/>
        </p:nvSpPr>
        <p:spPr>
          <a:xfrm>
            <a:off x="235080" y="624852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igure S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TextBox 61"/>
          <p:cNvSpPr/>
          <p:nvPr/>
        </p:nvSpPr>
        <p:spPr>
          <a:xfrm>
            <a:off x="2621880" y="4170240"/>
            <a:ext cx="441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NA-NC                                                                     LNA-20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TextBox 59"/>
          <p:cNvSpPr/>
          <p:nvPr/>
        </p:nvSpPr>
        <p:spPr>
          <a:xfrm>
            <a:off x="689040" y="322884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BS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TextBox 60"/>
          <p:cNvSpPr/>
          <p:nvPr/>
        </p:nvSpPr>
        <p:spPr>
          <a:xfrm>
            <a:off x="776160" y="2103480"/>
            <a:ext cx="44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tr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左大括号 24"/>
          <p:cNvSpPr/>
          <p:nvPr/>
        </p:nvSpPr>
        <p:spPr>
          <a:xfrm rot="16200000">
            <a:off x="2938680" y="2657160"/>
            <a:ext cx="107640" cy="2879640"/>
          </a:xfrm>
          <a:custGeom>
            <a:avLst/>
            <a:gdLst>
              <a:gd name="textAreaLeft" fmla="*/ 68760 w 107640"/>
              <a:gd name="textAreaRight" fmla="*/ 108000 w 107640"/>
              <a:gd name="textAreaTop" fmla="*/ 2520 h 2879640"/>
              <a:gd name="textAreaBottom" fmla="*/ 2877120 h 28796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34"/>
                  <a:pt x="10800" y="67"/>
                </a:cubicBezTo>
                <a:lnTo>
                  <a:pt x="10800" y="10733"/>
                </a:lnTo>
                <a:cubicBezTo>
                  <a:pt x="10800" y="10767"/>
                  <a:pt x="5400" y="10800"/>
                  <a:pt x="0" y="10800"/>
                </a:cubicBezTo>
                <a:cubicBezTo>
                  <a:pt x="5400" y="10800"/>
                  <a:pt x="10800" y="10834"/>
                  <a:pt x="10800" y="10867"/>
                </a:cubicBezTo>
                <a:lnTo>
                  <a:pt x="10800" y="21533"/>
                </a:lnTo>
                <a:cubicBezTo>
                  <a:pt x="10800" y="21567"/>
                  <a:pt x="16200" y="21600"/>
                  <a:pt x="21600" y="21600"/>
                </a:cubicBezTo>
              </a:path>
            </a:pathLst>
          </a:cu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Box 62"/>
          <p:cNvSpPr/>
          <p:nvPr/>
        </p:nvSpPr>
        <p:spPr>
          <a:xfrm>
            <a:off x="1474560" y="1366920"/>
            <a:ext cx="6423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Green                  Red                  Merge                   Green                 Red                 Merg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左大括号 27"/>
          <p:cNvSpPr/>
          <p:nvPr/>
        </p:nvSpPr>
        <p:spPr>
          <a:xfrm rot="16200000">
            <a:off x="6468840" y="2652480"/>
            <a:ext cx="108000" cy="2879640"/>
          </a:xfrm>
          <a:custGeom>
            <a:avLst/>
            <a:gdLst>
              <a:gd name="textAreaLeft" fmla="*/ 69120 w 108000"/>
              <a:gd name="textAreaRight" fmla="*/ 108360 w 108000"/>
              <a:gd name="textAreaTop" fmla="*/ 2520 h 2879640"/>
              <a:gd name="textAreaBottom" fmla="*/ 2877120 h 28796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34"/>
                  <a:pt x="10800" y="67"/>
                </a:cubicBezTo>
                <a:lnTo>
                  <a:pt x="10800" y="10733"/>
                </a:lnTo>
                <a:cubicBezTo>
                  <a:pt x="10800" y="10767"/>
                  <a:pt x="5400" y="10800"/>
                  <a:pt x="0" y="10800"/>
                </a:cubicBezTo>
                <a:cubicBezTo>
                  <a:pt x="5400" y="10800"/>
                  <a:pt x="10800" y="10834"/>
                  <a:pt x="10800" y="10867"/>
                </a:cubicBezTo>
                <a:lnTo>
                  <a:pt x="10800" y="21533"/>
                </a:lnTo>
                <a:cubicBezTo>
                  <a:pt x="10800" y="21567"/>
                  <a:pt x="16200" y="21600"/>
                  <a:pt x="21600" y="21600"/>
                </a:cubicBezTo>
              </a:path>
            </a:pathLst>
          </a:cu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Box 64"/>
          <p:cNvSpPr/>
          <p:nvPr/>
        </p:nvSpPr>
        <p:spPr>
          <a:xfrm>
            <a:off x="235080" y="624852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igure S6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4" name="图片 25" descr=""/>
          <p:cNvPicPr/>
          <p:nvPr/>
        </p:nvPicPr>
        <p:blipFill>
          <a:blip r:embed="rId1"/>
          <a:stretch/>
        </p:blipFill>
        <p:spPr>
          <a:xfrm>
            <a:off x="1322280" y="1716120"/>
            <a:ext cx="1081080" cy="1081080"/>
          </a:xfrm>
          <a:prstGeom prst="rect">
            <a:avLst/>
          </a:prstGeom>
          <a:ln w="0">
            <a:noFill/>
          </a:ln>
        </p:spPr>
      </p:pic>
      <p:pic>
        <p:nvPicPr>
          <p:cNvPr id="145" name="图片 29" descr=""/>
          <p:cNvPicPr/>
          <p:nvPr/>
        </p:nvPicPr>
        <p:blipFill>
          <a:blip r:embed="rId2"/>
          <a:stretch/>
        </p:blipFill>
        <p:spPr>
          <a:xfrm>
            <a:off x="3611520" y="1716120"/>
            <a:ext cx="1081080" cy="1081080"/>
          </a:xfrm>
          <a:prstGeom prst="rect">
            <a:avLst/>
          </a:prstGeom>
          <a:ln w="0">
            <a:noFill/>
          </a:ln>
        </p:spPr>
      </p:pic>
      <p:pic>
        <p:nvPicPr>
          <p:cNvPr id="146" name="图片 30" descr=""/>
          <p:cNvPicPr/>
          <p:nvPr/>
        </p:nvPicPr>
        <p:blipFill>
          <a:blip r:embed="rId3"/>
          <a:stretch/>
        </p:blipFill>
        <p:spPr>
          <a:xfrm>
            <a:off x="2462040" y="1716120"/>
            <a:ext cx="1079640" cy="1081080"/>
          </a:xfrm>
          <a:prstGeom prst="rect">
            <a:avLst/>
          </a:prstGeom>
          <a:ln w="0">
            <a:noFill/>
          </a:ln>
        </p:spPr>
      </p:pic>
      <p:pic>
        <p:nvPicPr>
          <p:cNvPr id="147" name="图片 31" descr=""/>
          <p:cNvPicPr/>
          <p:nvPr/>
        </p:nvPicPr>
        <p:blipFill>
          <a:blip r:embed="rId4"/>
          <a:stretch/>
        </p:blipFill>
        <p:spPr>
          <a:xfrm>
            <a:off x="4848120" y="1712880"/>
            <a:ext cx="1079640" cy="1079640"/>
          </a:xfrm>
          <a:prstGeom prst="rect">
            <a:avLst/>
          </a:prstGeom>
          <a:ln w="0">
            <a:noFill/>
          </a:ln>
        </p:spPr>
      </p:pic>
      <p:pic>
        <p:nvPicPr>
          <p:cNvPr id="148" name="图片 32" descr=""/>
          <p:cNvPicPr/>
          <p:nvPr/>
        </p:nvPicPr>
        <p:blipFill>
          <a:blip r:embed="rId5"/>
          <a:stretch/>
        </p:blipFill>
        <p:spPr>
          <a:xfrm>
            <a:off x="7147080" y="1712880"/>
            <a:ext cx="1079280" cy="1079640"/>
          </a:xfrm>
          <a:prstGeom prst="rect">
            <a:avLst/>
          </a:prstGeom>
          <a:ln w="0">
            <a:noFill/>
          </a:ln>
        </p:spPr>
      </p:pic>
      <p:pic>
        <p:nvPicPr>
          <p:cNvPr id="149" name="图片 33" descr=""/>
          <p:cNvPicPr/>
          <p:nvPr/>
        </p:nvPicPr>
        <p:blipFill>
          <a:blip r:embed="rId6"/>
          <a:stretch/>
        </p:blipFill>
        <p:spPr>
          <a:xfrm>
            <a:off x="5997600" y="1712880"/>
            <a:ext cx="1079640" cy="1079640"/>
          </a:xfrm>
          <a:prstGeom prst="rect">
            <a:avLst/>
          </a:prstGeom>
          <a:ln w="0">
            <a:noFill/>
          </a:ln>
        </p:spPr>
      </p:pic>
      <p:pic>
        <p:nvPicPr>
          <p:cNvPr id="150" name="图片 34" descr=""/>
          <p:cNvPicPr/>
          <p:nvPr/>
        </p:nvPicPr>
        <p:blipFill>
          <a:blip r:embed="rId7"/>
          <a:srcRect l="5556" t="0" r="7661" b="12913"/>
          <a:stretch/>
        </p:blipFill>
        <p:spPr>
          <a:xfrm>
            <a:off x="1322280" y="2895480"/>
            <a:ext cx="1081080" cy="1079640"/>
          </a:xfrm>
          <a:prstGeom prst="rect">
            <a:avLst/>
          </a:prstGeom>
          <a:ln w="0">
            <a:noFill/>
          </a:ln>
        </p:spPr>
      </p:pic>
      <p:pic>
        <p:nvPicPr>
          <p:cNvPr id="151" name="图片 35" descr=""/>
          <p:cNvPicPr/>
          <p:nvPr/>
        </p:nvPicPr>
        <p:blipFill>
          <a:blip r:embed="rId8"/>
          <a:srcRect l="5544" t="0" r="7652" b="12907"/>
          <a:stretch/>
        </p:blipFill>
        <p:spPr>
          <a:xfrm>
            <a:off x="3611520" y="2895480"/>
            <a:ext cx="1079640" cy="1079640"/>
          </a:xfrm>
          <a:prstGeom prst="rect">
            <a:avLst/>
          </a:prstGeom>
          <a:ln w="0">
            <a:noFill/>
          </a:ln>
        </p:spPr>
      </p:pic>
      <p:pic>
        <p:nvPicPr>
          <p:cNvPr id="152" name="图片 36" descr=""/>
          <p:cNvPicPr/>
          <p:nvPr/>
        </p:nvPicPr>
        <p:blipFill>
          <a:blip r:embed="rId9"/>
          <a:srcRect l="5544" t="0" r="7652" b="12907"/>
          <a:stretch/>
        </p:blipFill>
        <p:spPr>
          <a:xfrm>
            <a:off x="2462040" y="2895480"/>
            <a:ext cx="1079640" cy="1079640"/>
          </a:xfrm>
          <a:prstGeom prst="rect">
            <a:avLst/>
          </a:prstGeom>
          <a:ln w="0">
            <a:noFill/>
          </a:ln>
        </p:spPr>
      </p:pic>
      <p:pic>
        <p:nvPicPr>
          <p:cNvPr id="153" name="图片 37" descr=""/>
          <p:cNvPicPr/>
          <p:nvPr/>
        </p:nvPicPr>
        <p:blipFill>
          <a:blip r:embed="rId10"/>
          <a:stretch/>
        </p:blipFill>
        <p:spPr>
          <a:xfrm>
            <a:off x="4846680" y="2901960"/>
            <a:ext cx="1079280" cy="1081080"/>
          </a:xfrm>
          <a:prstGeom prst="rect">
            <a:avLst/>
          </a:prstGeom>
          <a:ln w="0">
            <a:noFill/>
          </a:ln>
        </p:spPr>
      </p:pic>
      <p:pic>
        <p:nvPicPr>
          <p:cNvPr id="154" name="图片 38" descr=""/>
          <p:cNvPicPr/>
          <p:nvPr/>
        </p:nvPicPr>
        <p:blipFill>
          <a:blip r:embed="rId11"/>
          <a:stretch/>
        </p:blipFill>
        <p:spPr>
          <a:xfrm>
            <a:off x="7149960" y="2901960"/>
            <a:ext cx="1079640" cy="1081080"/>
          </a:xfrm>
          <a:prstGeom prst="rect">
            <a:avLst/>
          </a:prstGeom>
          <a:ln w="0">
            <a:noFill/>
          </a:ln>
        </p:spPr>
      </p:pic>
      <p:pic>
        <p:nvPicPr>
          <p:cNvPr id="155" name="图片 39" descr=""/>
          <p:cNvPicPr/>
          <p:nvPr/>
        </p:nvPicPr>
        <p:blipFill>
          <a:blip r:embed="rId12"/>
          <a:stretch/>
        </p:blipFill>
        <p:spPr>
          <a:xfrm>
            <a:off x="5997600" y="2901960"/>
            <a:ext cx="1079640" cy="1081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TextBox 64"/>
          <p:cNvSpPr/>
          <p:nvPr/>
        </p:nvSpPr>
        <p:spPr>
          <a:xfrm>
            <a:off x="235080" y="624852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igure S7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Box 21"/>
          <p:cNvSpPr/>
          <p:nvPr/>
        </p:nvSpPr>
        <p:spPr>
          <a:xfrm>
            <a:off x="443880" y="1338120"/>
            <a:ext cx="5942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57160"/>
                <a:tab algn="l" pos="1714680"/>
                <a:tab algn="l" pos="2571840"/>
                <a:tab algn="l" pos="3429000"/>
                <a:tab algn="l" pos="4286160"/>
                <a:tab algn="l" pos="5143680"/>
                <a:tab algn="l" pos="6000840"/>
                <a:tab algn="l" pos="6858000"/>
                <a:tab algn="l" pos="7715160"/>
                <a:tab algn="l" pos="8572680"/>
                <a:tab algn="l" pos="9429840"/>
                <a:tab algn="l" pos="10287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                                          b                                                      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58" name="组合 38"/>
          <p:cNvGrpSpPr/>
          <p:nvPr/>
        </p:nvGrpSpPr>
        <p:grpSpPr>
          <a:xfrm>
            <a:off x="533520" y="1752480"/>
            <a:ext cx="2058840" cy="2462400"/>
            <a:chOff x="533520" y="1752480"/>
            <a:chExt cx="2058840" cy="2462400"/>
          </a:xfrm>
        </p:grpSpPr>
        <p:sp>
          <p:nvSpPr>
            <p:cNvPr id="159" name="TextBox 35"/>
            <p:cNvSpPr/>
            <p:nvPr/>
          </p:nvSpPr>
          <p:spPr>
            <a:xfrm rot="16200000">
              <a:off x="-357840" y="2790360"/>
              <a:ext cx="2059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lative levels of miR-20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60" name="图表 59" descr=""/>
            <p:cNvPicPr/>
            <p:nvPr/>
          </p:nvPicPr>
          <p:blipFill>
            <a:blip r:embed="rId1"/>
            <a:stretch/>
          </p:blipFill>
          <p:spPr>
            <a:xfrm>
              <a:off x="755280" y="1752480"/>
              <a:ext cx="1837080" cy="24624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61" name="组合 60"/>
          <p:cNvGrpSpPr/>
          <p:nvPr/>
        </p:nvGrpSpPr>
        <p:grpSpPr>
          <a:xfrm>
            <a:off x="2971800" y="1752480"/>
            <a:ext cx="3095640" cy="2513160"/>
            <a:chOff x="2971800" y="1752480"/>
            <a:chExt cx="3095640" cy="2513160"/>
          </a:xfrm>
        </p:grpSpPr>
        <p:sp>
          <p:nvSpPr>
            <p:cNvPr id="162" name="TextBox 52"/>
            <p:cNvSpPr/>
            <p:nvPr/>
          </p:nvSpPr>
          <p:spPr>
            <a:xfrm rot="16200000">
              <a:off x="2237760" y="2771280"/>
              <a:ext cx="1744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lative mRNA level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TextBox 53"/>
            <p:cNvSpPr/>
            <p:nvPr/>
          </p:nvSpPr>
          <p:spPr>
            <a:xfrm>
              <a:off x="4773600" y="2826360"/>
              <a:ext cx="235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TextBox 54"/>
            <p:cNvSpPr/>
            <p:nvPr/>
          </p:nvSpPr>
          <p:spPr>
            <a:xfrm>
              <a:off x="5537880" y="2662200"/>
              <a:ext cx="290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TextBox 55"/>
            <p:cNvSpPr/>
            <p:nvPr/>
          </p:nvSpPr>
          <p:spPr>
            <a:xfrm>
              <a:off x="3951720" y="2488320"/>
              <a:ext cx="290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66" name="图表 65" descr=""/>
            <p:cNvPicPr/>
            <p:nvPr/>
          </p:nvPicPr>
          <p:blipFill>
            <a:blip r:embed="rId2"/>
            <a:stretch/>
          </p:blipFill>
          <p:spPr>
            <a:xfrm>
              <a:off x="3193920" y="1752480"/>
              <a:ext cx="2873520" cy="25131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67" name="组合 3"/>
          <p:cNvGrpSpPr/>
          <p:nvPr/>
        </p:nvGrpSpPr>
        <p:grpSpPr>
          <a:xfrm>
            <a:off x="6404400" y="1578600"/>
            <a:ext cx="1902600" cy="2472480"/>
            <a:chOff x="6404400" y="1578600"/>
            <a:chExt cx="1902600" cy="2472480"/>
          </a:xfrm>
        </p:grpSpPr>
        <p:pic>
          <p:nvPicPr>
            <p:cNvPr id="168" name="Picture 2" descr=""/>
            <p:cNvPicPr/>
            <p:nvPr/>
          </p:nvPicPr>
          <p:blipFill>
            <a:blip r:embed="rId3">
              <a:lum bright="-10000"/>
            </a:blip>
            <a:stretch/>
          </p:blipFill>
          <p:spPr>
            <a:xfrm>
              <a:off x="6416280" y="2199600"/>
              <a:ext cx="1080360" cy="25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69" name="Picture 3" descr=""/>
            <p:cNvPicPr/>
            <p:nvPr/>
          </p:nvPicPr>
          <p:blipFill>
            <a:blip r:embed="rId4">
              <a:lum bright="-10000"/>
            </a:blip>
            <a:stretch/>
          </p:blipFill>
          <p:spPr>
            <a:xfrm>
              <a:off x="6416280" y="2502000"/>
              <a:ext cx="1080360" cy="25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70" name="Picture 7" descr=""/>
            <p:cNvPicPr/>
            <p:nvPr/>
          </p:nvPicPr>
          <p:blipFill>
            <a:blip r:embed="rId5">
              <a:lum contrast="20000"/>
            </a:blip>
            <a:stretch/>
          </p:blipFill>
          <p:spPr>
            <a:xfrm>
              <a:off x="6416280" y="2799000"/>
              <a:ext cx="1080360" cy="25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71" name="Picture 8" descr=""/>
            <p:cNvPicPr/>
            <p:nvPr/>
          </p:nvPicPr>
          <p:blipFill>
            <a:blip r:embed="rId6"/>
            <a:srcRect l="0" t="8367" r="0" b="8367"/>
            <a:stretch/>
          </p:blipFill>
          <p:spPr>
            <a:xfrm>
              <a:off x="6416280" y="3792960"/>
              <a:ext cx="1080360" cy="25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172" name="TextBox 43"/>
            <p:cNvSpPr/>
            <p:nvPr/>
          </p:nvSpPr>
          <p:spPr>
            <a:xfrm>
              <a:off x="7512120" y="2191680"/>
              <a:ext cx="7948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G16L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TextBox 44"/>
            <p:cNvSpPr/>
            <p:nvPr/>
          </p:nvSpPr>
          <p:spPr>
            <a:xfrm>
              <a:off x="7498080" y="2476080"/>
              <a:ext cx="756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QSTM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TextBox 45"/>
            <p:cNvSpPr/>
            <p:nvPr/>
          </p:nvSpPr>
          <p:spPr>
            <a:xfrm>
              <a:off x="7508520" y="2798280"/>
              <a:ext cx="6530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BECN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TextBox 46"/>
            <p:cNvSpPr/>
            <p:nvPr/>
          </p:nvSpPr>
          <p:spPr>
            <a:xfrm>
              <a:off x="7499520" y="3789720"/>
              <a:ext cx="685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PDH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TextBox 47"/>
            <p:cNvSpPr/>
            <p:nvPr/>
          </p:nvSpPr>
          <p:spPr>
            <a:xfrm rot="19106400">
              <a:off x="6416280" y="1775160"/>
              <a:ext cx="5922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Lv-NC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TextBox 48"/>
            <p:cNvSpPr/>
            <p:nvPr/>
          </p:nvSpPr>
          <p:spPr>
            <a:xfrm rot="19106400">
              <a:off x="6936120" y="1752480"/>
              <a:ext cx="624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Lv-20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aphicFrame>
          <p:nvGraphicFramePr>
            <p:cNvPr id="178" name="Object 25"/>
            <p:cNvGraphicFramePr/>
            <p:nvPr/>
          </p:nvGraphicFramePr>
          <p:xfrm>
            <a:off x="6416280" y="3416400"/>
            <a:ext cx="1080360" cy="32400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179" name="Object 25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6416280" y="3416400"/>
                      <a:ext cx="1080360" cy="324000"/>
                    </a:xfrm>
                    <a:prstGeom prst="rect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sp>
          <p:nvSpPr>
            <p:cNvPr id="180" name="TextBox 46"/>
            <p:cNvSpPr/>
            <p:nvPr/>
          </p:nvSpPr>
          <p:spPr>
            <a:xfrm>
              <a:off x="7496640" y="3370680"/>
              <a:ext cx="57096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-I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-II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aphicFrame>
          <p:nvGraphicFramePr>
            <p:cNvPr id="181" name="Object 26"/>
            <p:cNvGraphicFramePr/>
            <p:nvPr/>
          </p:nvGraphicFramePr>
          <p:xfrm>
            <a:off x="6416280" y="3107160"/>
            <a:ext cx="1080360" cy="25200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182" name="Object 26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6416280" y="3107160"/>
                      <a:ext cx="1080360" cy="252000"/>
                    </a:xfrm>
                    <a:prstGeom prst="rect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sp>
          <p:nvSpPr>
            <p:cNvPr id="183" name="TextBox 45"/>
            <p:cNvSpPr/>
            <p:nvPr/>
          </p:nvSpPr>
          <p:spPr>
            <a:xfrm>
              <a:off x="7498080" y="3100680"/>
              <a:ext cx="569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57160"/>
                  <a:tab algn="l" pos="1714680"/>
                  <a:tab algn="l" pos="2571840"/>
                  <a:tab algn="l" pos="3429000"/>
                  <a:tab algn="l" pos="4286160"/>
                  <a:tab algn="l" pos="5143680"/>
                  <a:tab algn="l" pos="6000840"/>
                  <a:tab algn="l" pos="6858000"/>
                  <a:tab algn="l" pos="7715160"/>
                  <a:tab algn="l" pos="8572680"/>
                  <a:tab algn="l" pos="9429840"/>
                  <a:tab algn="l" pos="10287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OPTN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4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7-15T08:27:58Z</dcterms:created>
  <dc:creator>xuxubear</dc:creator>
  <dc:description/>
  <dc:language>en-US</dc:language>
  <cp:lastModifiedBy>vidya.p</cp:lastModifiedBy>
  <dcterms:modified xsi:type="dcterms:W3CDTF">2017-06-13T08:59:19Z</dcterms:modified>
  <cp:revision>125</cp:revision>
  <dc:subject/>
  <dc:title>幻灯片 1</dc:title>
</cp:coreProperties>
</file>